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9144000" cy="6858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Stile medio 2 - Color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52"/>
    <p:restoredTop sz="94674"/>
  </p:normalViewPr>
  <p:slideViewPr>
    <p:cSldViewPr snapToGrid="0" snapToObjects="1">
      <p:cViewPr>
        <p:scale>
          <a:sx n="162" d="100"/>
          <a:sy n="162" d="100"/>
        </p:scale>
        <p:origin x="-2312" y="-2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19/08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2389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19/08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6773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19/08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4660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19/08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8660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19/08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3028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19/08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9583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19/08/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6211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19/08/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9444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19/08/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134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19/08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7183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8B937-3AF9-BF46-8F07-84A4369BAD49}" type="datetimeFigureOut">
              <a:rPr lang="it-IT" smtClean="0"/>
              <a:t>19/08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E5F293-5EF3-A84C-A038-7785EEF6387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20657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D8B937-3AF9-BF46-8F07-84A4369BAD49}" type="datetimeFigureOut">
              <a:rPr lang="it-IT" smtClean="0"/>
              <a:t>19/08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E5F293-5EF3-A84C-A038-7785EEF6387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1713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>
            <a:extLst>
              <a:ext uri="{FF2B5EF4-FFF2-40B4-BE49-F238E27FC236}">
                <a16:creationId xmlns:a16="http://schemas.microsoft.com/office/drawing/2014/main" xmlns="" id="{9A518CFF-2B2E-F149-9EE2-EFD77D525B8F}"/>
              </a:ext>
            </a:extLst>
          </p:cNvPr>
          <p:cNvSpPr/>
          <p:nvPr/>
        </p:nvSpPr>
        <p:spPr>
          <a:xfrm>
            <a:off x="6402842" y="5614459"/>
            <a:ext cx="19343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altLang="it-IT" sz="1200" b="1" dirty="0" err="1">
                <a:latin typeface="Times New Roman" charset="0"/>
                <a:ea typeface="Times New Roman" charset="0"/>
                <a:cs typeface="Times New Roman" charset="0"/>
              </a:rPr>
              <a:t>Additional</a:t>
            </a:r>
            <a:r>
              <a:rPr lang="it-IT" altLang="it-IT" sz="1200" b="1" dirty="0">
                <a:latin typeface="Times New Roman" charset="0"/>
                <a:ea typeface="Times New Roman" charset="0"/>
                <a:cs typeface="Times New Roman" charset="0"/>
              </a:rPr>
              <a:t> file 2: </a:t>
            </a:r>
            <a:r>
              <a:rPr lang="it-IT" altLang="it-IT" sz="1200" b="1" dirty="0" err="1">
                <a:latin typeface="Times New Roman" charset="0"/>
                <a:ea typeface="Times New Roman" charset="0"/>
                <a:cs typeface="Times New Roman" charset="0"/>
              </a:rPr>
              <a:t>Table</a:t>
            </a:r>
            <a:r>
              <a:rPr lang="it-IT" altLang="it-IT" sz="1200" b="1" dirty="0">
                <a:latin typeface="Times New Roman" charset="0"/>
                <a:ea typeface="Times New Roman" charset="0"/>
                <a:cs typeface="Times New Roman" charset="0"/>
              </a:rPr>
              <a:t> S1</a:t>
            </a:r>
            <a:r>
              <a:rPr lang="it-IT" altLang="it-IT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lang="it-IT" sz="1200" dirty="0"/>
          </a:p>
        </p:txBody>
      </p:sp>
      <p:graphicFrame>
        <p:nvGraphicFramePr>
          <p:cNvPr id="3" name="Tabella 2">
            <a:extLst>
              <a:ext uri="{FF2B5EF4-FFF2-40B4-BE49-F238E27FC236}">
                <a16:creationId xmlns:a16="http://schemas.microsoft.com/office/drawing/2014/main" xmlns="" id="{F1637841-44B1-224D-B5E6-0CDEBE8AF0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7290760"/>
              </p:ext>
            </p:extLst>
          </p:nvPr>
        </p:nvGraphicFramePr>
        <p:xfrm>
          <a:off x="1809347" y="1669091"/>
          <a:ext cx="6363103" cy="388003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91283">
                  <a:extLst>
                    <a:ext uri="{9D8B030D-6E8A-4147-A177-3AD203B41FA5}">
                      <a16:colId xmlns:a16="http://schemas.microsoft.com/office/drawing/2014/main" xmlns="" val="3644324167"/>
                    </a:ext>
                  </a:extLst>
                </a:gridCol>
                <a:gridCol w="1066811">
                  <a:extLst>
                    <a:ext uri="{9D8B030D-6E8A-4147-A177-3AD203B41FA5}">
                      <a16:colId xmlns:a16="http://schemas.microsoft.com/office/drawing/2014/main" xmlns="" val="280251661"/>
                    </a:ext>
                  </a:extLst>
                </a:gridCol>
                <a:gridCol w="2520697">
                  <a:extLst>
                    <a:ext uri="{9D8B030D-6E8A-4147-A177-3AD203B41FA5}">
                      <a16:colId xmlns:a16="http://schemas.microsoft.com/office/drawing/2014/main" xmlns="" val="1746466381"/>
                    </a:ext>
                  </a:extLst>
                </a:gridCol>
                <a:gridCol w="623093">
                  <a:extLst>
                    <a:ext uri="{9D8B030D-6E8A-4147-A177-3AD203B41FA5}">
                      <a16:colId xmlns:a16="http://schemas.microsoft.com/office/drawing/2014/main" xmlns="" val="2470551910"/>
                    </a:ext>
                  </a:extLst>
                </a:gridCol>
                <a:gridCol w="1161219">
                  <a:extLst>
                    <a:ext uri="{9D8B030D-6E8A-4147-A177-3AD203B41FA5}">
                      <a16:colId xmlns:a16="http://schemas.microsoft.com/office/drawing/2014/main" xmlns="" val="33965114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900" b="1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Genese</a:t>
                      </a:r>
                      <a:endParaRPr lang="it-IT" sz="900" dirty="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900" b="1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GenBank</a:t>
                      </a:r>
                      <a:endParaRPr lang="it-IT" sz="900" dirty="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GB" sz="900" b="1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ccession no.</a:t>
                      </a:r>
                      <a:endParaRPr lang="it-IT" sz="900" dirty="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9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s</a:t>
                      </a:r>
                      <a:r>
                        <a:rPr lang="it-IT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it-IT" sz="9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s</a:t>
                      </a:r>
                      <a:endParaRPr lang="it-IT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it-IT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</a:t>
                      </a:r>
                      <a:endParaRPr lang="it-IT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it-IT" sz="9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con</a:t>
                      </a:r>
                      <a:r>
                        <a:rPr lang="it-IT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it-IT" sz="9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ze</a:t>
                      </a:r>
                      <a:r>
                        <a:rPr lang="it-IT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it-IT" sz="9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p</a:t>
                      </a:r>
                      <a:r>
                        <a:rPr lang="it-IT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it-IT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extLst>
                  <a:ext uri="{0D108BD9-81ED-4DB2-BD59-A6C34878D82A}">
                    <a16:rowId xmlns:a16="http://schemas.microsoft.com/office/drawing/2014/main" xmlns="" val="3364058424"/>
                  </a:ext>
                </a:extLst>
              </a:tr>
              <a:tr h="122617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FAD2.1</a:t>
                      </a:r>
                      <a:endParaRPr lang="it-IT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HQ908422 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 5’- GCAATCAAGCCACTATTAGGTG -3’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it-IT" sz="800" b="1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42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t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</a:t>
                      </a:r>
                      <a:endParaRPr lang="it-IT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extLst>
                  <a:ext uri="{0D108BD9-81ED-4DB2-BD59-A6C34878D82A}">
                    <a16:rowId xmlns:a16="http://schemas.microsoft.com/office/drawing/2014/main" xmlns="" val="3513790909"/>
                  </a:ext>
                </a:extLst>
              </a:tr>
              <a:tr h="12261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’- GACATAAAGACACTCCTTCGC-3’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628901985"/>
                  </a:ext>
                </a:extLst>
              </a:tr>
              <a:tr h="122617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FAD2.2</a:t>
                      </a:r>
                      <a:endParaRPr lang="it-IT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HQ908423.1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 5’- GCAATTAAGCCGATATTAGGG-3’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42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extLst>
                  <a:ext uri="{0D108BD9-81ED-4DB2-BD59-A6C34878D82A}">
                    <a16:rowId xmlns:a16="http://schemas.microsoft.com/office/drawing/2014/main" xmlns="" val="303568864"/>
                  </a:ext>
                </a:extLst>
              </a:tr>
              <a:tr h="12261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’- CATTCCTTCGCTTCTCTCC-3’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354356842"/>
                  </a:ext>
                </a:extLst>
              </a:tr>
              <a:tr h="122617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D6</a:t>
                      </a:r>
                      <a:endParaRPr lang="it-IT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Y77218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 5’- GAACGAGGCTACATGGAAC-3’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23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extLst>
                  <a:ext uri="{0D108BD9-81ED-4DB2-BD59-A6C34878D82A}">
                    <a16:rowId xmlns:a16="http://schemas.microsoft.com/office/drawing/2014/main" xmlns="" val="156979146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’- GTTGTGAATCTTTGGGTGC-3’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78239248"/>
                  </a:ext>
                </a:extLst>
              </a:tr>
              <a:tr h="122617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FAD7</a:t>
                      </a:r>
                      <a:endParaRPr lang="it-IT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Q889832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 5'-CCCATGTCATACATCACCTC-3'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42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extLst>
                  <a:ext uri="{0D108BD9-81ED-4DB2-BD59-A6C34878D82A}">
                    <a16:rowId xmlns:a16="http://schemas.microsoft.com/office/drawing/2014/main" xmlns="" val="1831763927"/>
                  </a:ext>
                </a:extLst>
              </a:tr>
              <a:tr h="12261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'-GCAAATACAATGGAAGAGGC-3'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679032408"/>
                  </a:ext>
                </a:extLst>
              </a:tr>
              <a:tr h="122617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SLS1</a:t>
                      </a:r>
                      <a:endParaRPr lang="it-IT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X266184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 5’- GTGAAGTGGATGTGTGGCCT-3’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20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extLst>
                  <a:ext uri="{0D108BD9-81ED-4DB2-BD59-A6C34878D82A}">
                    <a16:rowId xmlns:a16="http://schemas.microsoft.com/office/drawing/2014/main" xmlns="" val="4252180718"/>
                  </a:ext>
                </a:extLst>
              </a:tr>
              <a:tr h="12261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’- CAACTCAAATAAAACGCCGG-3’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12577298"/>
                  </a:ext>
                </a:extLst>
              </a:tr>
              <a:tr h="122617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PAL</a:t>
                      </a:r>
                      <a:endParaRPr lang="it-IT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X266200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 5’- AATGGGGAGCTTCATCCATCA -3’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20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5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extLst>
                  <a:ext uri="{0D108BD9-81ED-4DB2-BD59-A6C34878D82A}">
                    <a16:rowId xmlns:a16="http://schemas.microsoft.com/office/drawing/2014/main" xmlns="" val="80654430"/>
                  </a:ext>
                </a:extLst>
              </a:tr>
              <a:tr h="126775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’- AGAAATGTGGATGACATAAGCTTCA -3’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6185668"/>
                  </a:ext>
                </a:extLst>
              </a:tr>
              <a:tr h="122617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CUAO</a:t>
                      </a:r>
                      <a:endParaRPr lang="it-IT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Q851613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 5’- AAGATGGCCTTGGGAAGAAT -3’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20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1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extLst>
                  <a:ext uri="{0D108BD9-81ED-4DB2-BD59-A6C34878D82A}">
                    <a16:rowId xmlns:a16="http://schemas.microsoft.com/office/drawing/2014/main" xmlns="" val="3176336683"/>
                  </a:ext>
                </a:extLst>
              </a:tr>
              <a:tr h="12261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’- TTCTGCCAATCCTGTTCTCC -3’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803090288"/>
                  </a:ext>
                </a:extLst>
              </a:tr>
              <a:tr h="122617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ALDH1</a:t>
                      </a:r>
                      <a:endParaRPr lang="it-IT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X266197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 5’- TTTAAGTGGGGAGCTCAAATACA-3’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20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extLst>
                  <a:ext uri="{0D108BD9-81ED-4DB2-BD59-A6C34878D82A}">
                    <a16:rowId xmlns:a16="http://schemas.microsoft.com/office/drawing/2014/main" xmlns="" val="297730921"/>
                  </a:ext>
                </a:extLst>
              </a:tr>
              <a:tr h="12261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’- GATGCTTCAGATATTCCCATGC-3’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322205040"/>
                  </a:ext>
                </a:extLst>
              </a:tr>
              <a:tr h="122617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EF1</a:t>
                      </a:r>
                      <a:r>
                        <a:rPr lang="el-GR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</a:t>
                      </a:r>
                      <a:endParaRPr lang="el-GR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946404</a:t>
                      </a:r>
                      <a:endParaRPr lang="it-IT" sz="800" b="1" i="0" u="none" strike="noStrike">
                        <a:solidFill>
                          <a:srgbClr val="44444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 5’- ACCACTGGTGGTTTTGAAGC -3’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20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4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extLst>
                  <a:ext uri="{0D108BD9-81ED-4DB2-BD59-A6C34878D82A}">
                    <a16:rowId xmlns:a16="http://schemas.microsoft.com/office/drawing/2014/main" xmlns="" val="1022472963"/>
                  </a:ext>
                </a:extLst>
              </a:tr>
              <a:tr h="12261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’- GAAACCAGAGATGGGGACAA-3’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544859674"/>
                  </a:ext>
                </a:extLst>
              </a:tr>
              <a:tr h="122617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CRY2</a:t>
                      </a:r>
                      <a:endParaRPr lang="it-IT" sz="800" b="1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8NTSAO03GWZ77</a:t>
                      </a:r>
                      <a:endParaRPr lang="it-IT" sz="800" b="1" i="0" u="none" strike="noStrike">
                        <a:solidFill>
                          <a:srgbClr val="44444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 5’- GTCCTACAAGCTCGTCCTATG -3’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42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4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extLst>
                  <a:ext uri="{0D108BD9-81ED-4DB2-BD59-A6C34878D82A}">
                    <a16:rowId xmlns:a16="http://schemas.microsoft.com/office/drawing/2014/main" xmlns="" val="4225778294"/>
                  </a:ext>
                </a:extLst>
              </a:tr>
              <a:tr h="12261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’- CTTGTCGCAACTATGCAAGT-3’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373722295"/>
                  </a:ext>
                </a:extLst>
              </a:tr>
              <a:tr h="122617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sARF</a:t>
                      </a:r>
                      <a:endParaRPr lang="it-IT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031316.1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 5'-TGAGACCCAAAAAGGACCAC-3'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43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extLst>
                  <a:ext uri="{0D108BD9-81ED-4DB2-BD59-A6C34878D82A}">
                    <a16:rowId xmlns:a16="http://schemas.microsoft.com/office/drawing/2014/main" xmlns="" val="2854764328"/>
                  </a:ext>
                </a:extLst>
              </a:tr>
              <a:tr h="122617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'-CTTCCCTCCACTTGGGTTCT-3'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92461580"/>
                  </a:ext>
                </a:extLst>
              </a:tr>
              <a:tr h="126573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sH3</a:t>
                      </a:r>
                      <a:endParaRPr lang="it-IT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004654.1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W 5'-CTACCATTCCAGCGTTTGGT-3'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43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t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extLst>
                  <a:ext uri="{0D108BD9-81ED-4DB2-BD59-A6C34878D82A}">
                    <a16:rowId xmlns:a16="http://schemas.microsoft.com/office/drawing/2014/main" xmlns="" val="266681916"/>
                  </a:ext>
                </a:extLst>
              </a:tr>
              <a:tr h="12657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t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'-GACCCACAAGGTAAGCCT-3'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469506730"/>
                  </a:ext>
                </a:extLst>
              </a:tr>
              <a:tr h="134484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sDHN</a:t>
                      </a:r>
                      <a:r>
                        <a:rPr lang="it-IT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it-IT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349290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 5′-AAGGAGAAGCTCCCTGGGTA-3'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44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6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extLst>
                  <a:ext uri="{0D108BD9-81ED-4DB2-BD59-A6C34878D82A}">
                    <a16:rowId xmlns:a16="http://schemas.microsoft.com/office/drawing/2014/main" xmlns="" val="2827144318"/>
                  </a:ext>
                </a:extLst>
              </a:tr>
              <a:tr h="134484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′-AAACCACCAAAGAAGAAATCAAA -3′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361090671"/>
                  </a:ext>
                </a:extLst>
              </a:tr>
              <a:tr h="126573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GGH</a:t>
                      </a:r>
                      <a:endParaRPr lang="it-IT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Q424963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W 5'-CCAAGGGAGGCATTTGTAGA-3'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38]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/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4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extLst>
                  <a:ext uri="{0D108BD9-81ED-4DB2-BD59-A6C34878D82A}">
                    <a16:rowId xmlns:a16="http://schemas.microsoft.com/office/drawing/2014/main" xmlns="" val="1521434451"/>
                  </a:ext>
                </a:extLst>
              </a:tr>
              <a:tr h="134484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W 5'-TGGATTCACAGCCAATTTCA-3'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3" marR="5933" marT="5933" marB="0" anchor="ctr"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452978926"/>
                  </a:ext>
                </a:extLst>
              </a:tr>
            </a:tbl>
          </a:graphicData>
        </a:graphic>
      </p:graphicFrame>
      <p:sp>
        <p:nvSpPr>
          <p:cNvPr id="5" name="CasellaDiTesto 4">
            <a:extLst>
              <a:ext uri="{FF2B5EF4-FFF2-40B4-BE49-F238E27FC236}">
                <a16:creationId xmlns:a16="http://schemas.microsoft.com/office/drawing/2014/main" xmlns="" id="{06512B94-7545-4348-9DC4-E0976330158D}"/>
              </a:ext>
            </a:extLst>
          </p:cNvPr>
          <p:cNvSpPr txBox="1"/>
          <p:nvPr/>
        </p:nvSpPr>
        <p:spPr>
          <a:xfrm>
            <a:off x="2383186" y="988200"/>
            <a:ext cx="53026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st of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ed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ess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ough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T-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PCR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9006841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</TotalTime>
  <Words>276</Words>
  <Application>Microsoft Macintosh PowerPoint</Application>
  <PresentationFormat>A4 (21x29,7 cm)</PresentationFormat>
  <Paragraphs>9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Tema di Office</vt:lpstr>
      <vt:lpstr>Presentazione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 di Microsoft Office</dc:creator>
  <cp:lastModifiedBy>Beatrice Bitonti</cp:lastModifiedBy>
  <cp:revision>18</cp:revision>
  <dcterms:created xsi:type="dcterms:W3CDTF">2018-10-03T10:37:59Z</dcterms:created>
  <dcterms:modified xsi:type="dcterms:W3CDTF">2019-08-19T21:10:43Z</dcterms:modified>
</cp:coreProperties>
</file>